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73FB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22"/>
    <p:restoredTop sz="96405"/>
  </p:normalViewPr>
  <p:slideViewPr>
    <p:cSldViewPr snapToGrid="0">
      <p:cViewPr varScale="1">
        <p:scale>
          <a:sx n="96" d="100"/>
          <a:sy n="96" d="100"/>
        </p:scale>
        <p:origin x="27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C2A15-5DBB-F74A-909F-0471B1CCE8E3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34358D-359D-DF4D-B16A-6BA48F09DF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8489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3925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6046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3004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1793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579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236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9875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2318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793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436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695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876F1F-6040-6B47-824C-70A4327000A1}" type="datetimeFigureOut">
              <a:rPr kumimoji="1" lang="ja-JP" altLang="en-US" smtClean="0"/>
              <a:t>2025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3DA72-CDF4-AE46-A5C9-8ABF2DCD14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0484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BBEA0714-A1E2-660D-DCF3-2BE0DCC682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738" y="893248"/>
            <a:ext cx="5446855" cy="599873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23C764A-AB63-66E3-5911-DE1F6E1D6894}"/>
              </a:ext>
            </a:extLst>
          </p:cNvPr>
          <p:cNvSpPr txBox="1"/>
          <p:nvPr/>
        </p:nvSpPr>
        <p:spPr>
          <a:xfrm>
            <a:off x="763733" y="6738339"/>
            <a:ext cx="553315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 Principal components analysis using unlinked SNPs (r</a:t>
            </a:r>
            <a:r>
              <a:rPr kumimoji="1" lang="en-US" altLang="ja-JP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0.8).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ores of each individual for PC1 and PC2 were obtained using 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adapt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[46]. Three genetic groups were shown in blue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a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yellow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mote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and red (</a:t>
            </a:r>
            <a:r>
              <a:rPr kumimoji="1" lang="en-US" altLang="ja-JP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aku-sugi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kumimoji="1" lang="ja-JP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図 8">
            <a:extLst>
              <a:ext uri="{FF2B5EF4-FFF2-40B4-BE49-F238E27FC236}">
                <a16:creationId xmlns:a16="http://schemas.microsoft.com/office/drawing/2014/main" id="{4E37DA8F-8820-7363-7886-2F6BC462C9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463389" y="1687081"/>
            <a:ext cx="827314" cy="696686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398772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895</TotalTime>
  <Words>46</Words>
  <Application>Microsoft Macintosh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/>
  <cp:keywords/>
  <dc:description/>
  <cp:lastModifiedBy>Ihara Tokuko</cp:lastModifiedBy>
  <cp:revision>83</cp:revision>
  <cp:lastPrinted>2023-10-10T08:11:58Z</cp:lastPrinted>
  <dcterms:created xsi:type="dcterms:W3CDTF">2023-07-12T06:47:41Z</dcterms:created>
  <dcterms:modified xsi:type="dcterms:W3CDTF">2025-08-29T07:21:31Z</dcterms:modified>
  <cp:category/>
</cp:coreProperties>
</file>